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12" d="100"/>
          <a:sy n="112" d="100"/>
        </p:scale>
        <p:origin x="1445" y="-36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9058E-E0B8-4DA6-91D5-D2DAEA9847B2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ADC08-C6B1-41E5-B3C4-DA67A9A84CA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0545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9058E-E0B8-4DA6-91D5-D2DAEA9847B2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ADC08-C6B1-41E5-B3C4-DA67A9A84CA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541657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9058E-E0B8-4DA6-91D5-D2DAEA9847B2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ADC08-C6B1-41E5-B3C4-DA67A9A84CA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60077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9058E-E0B8-4DA6-91D5-D2DAEA9847B2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ADC08-C6B1-41E5-B3C4-DA67A9A84CA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7001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9058E-E0B8-4DA6-91D5-D2DAEA9847B2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ADC08-C6B1-41E5-B3C4-DA67A9A84CA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3186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9058E-E0B8-4DA6-91D5-D2DAEA9847B2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ADC08-C6B1-41E5-B3C4-DA67A9A84CA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29403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9058E-E0B8-4DA6-91D5-D2DAEA9847B2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ADC08-C6B1-41E5-B3C4-DA67A9A84CA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7945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9058E-E0B8-4DA6-91D5-D2DAEA9847B2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ADC08-C6B1-41E5-B3C4-DA67A9A84CA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3279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9058E-E0B8-4DA6-91D5-D2DAEA9847B2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ADC08-C6B1-41E5-B3C4-DA67A9A84CA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95385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9058E-E0B8-4DA6-91D5-D2DAEA9847B2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ADC08-C6B1-41E5-B3C4-DA67A9A84CA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321550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9058E-E0B8-4DA6-91D5-D2DAEA9847B2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4ADC08-C6B1-41E5-B3C4-DA67A9A84CA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2681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C9058E-E0B8-4DA6-91D5-D2DAEA9847B2}" type="datetimeFigureOut">
              <a:rPr lang="de-DE" smtClean="0"/>
              <a:t>03.10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4ADC08-C6B1-41E5-B3C4-DA67A9A84CA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209499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>
            <a:extLst>
              <a:ext uri="{FF2B5EF4-FFF2-40B4-BE49-F238E27FC236}">
                <a16:creationId xmlns:a16="http://schemas.microsoft.com/office/drawing/2014/main" id="{54C49931-F092-471D-BA26-AE8089F9E401}"/>
              </a:ext>
            </a:extLst>
          </p:cNvPr>
          <p:cNvGrpSpPr/>
          <p:nvPr/>
        </p:nvGrpSpPr>
        <p:grpSpPr>
          <a:xfrm>
            <a:off x="0" y="2333894"/>
            <a:ext cx="7062283" cy="5664946"/>
            <a:chOff x="-86716" y="657493"/>
            <a:chExt cx="7062283" cy="5664946"/>
          </a:xfrm>
        </p:grpSpPr>
        <p:sp>
          <p:nvSpPr>
            <p:cNvPr id="5" name="Textfeld 4">
              <a:extLst>
                <a:ext uri="{FF2B5EF4-FFF2-40B4-BE49-F238E27FC236}">
                  <a16:creationId xmlns:a16="http://schemas.microsoft.com/office/drawing/2014/main" id="{5AC377DC-C235-4338-8919-D21AE1A4C705}"/>
                </a:ext>
              </a:extLst>
            </p:cNvPr>
            <p:cNvSpPr txBox="1"/>
            <p:nvPr/>
          </p:nvSpPr>
          <p:spPr>
            <a:xfrm>
              <a:off x="147166" y="689557"/>
              <a:ext cx="489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6" name="Textfeld 5">
              <a:extLst>
                <a:ext uri="{FF2B5EF4-FFF2-40B4-BE49-F238E27FC236}">
                  <a16:creationId xmlns:a16="http://schemas.microsoft.com/office/drawing/2014/main" id="{1103AE83-D814-44A4-ACF7-C333C2134557}"/>
                </a:ext>
              </a:extLst>
            </p:cNvPr>
            <p:cNvSpPr txBox="1"/>
            <p:nvPr/>
          </p:nvSpPr>
          <p:spPr>
            <a:xfrm>
              <a:off x="3521526" y="657493"/>
              <a:ext cx="489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7" name="Textfeld 6">
              <a:extLst>
                <a:ext uri="{FF2B5EF4-FFF2-40B4-BE49-F238E27FC236}">
                  <a16:creationId xmlns:a16="http://schemas.microsoft.com/office/drawing/2014/main" id="{5DF47D67-53D0-4351-93EA-3F31B8E58373}"/>
                </a:ext>
              </a:extLst>
            </p:cNvPr>
            <p:cNvSpPr txBox="1"/>
            <p:nvPr/>
          </p:nvSpPr>
          <p:spPr>
            <a:xfrm>
              <a:off x="880092" y="697146"/>
              <a:ext cx="190813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Total 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ohort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, HPV+</a:t>
              </a:r>
            </a:p>
          </p:txBody>
        </p:sp>
        <p:sp>
          <p:nvSpPr>
            <p:cNvPr id="8" name="Textfeld 7">
              <a:extLst>
                <a:ext uri="{FF2B5EF4-FFF2-40B4-BE49-F238E27FC236}">
                  <a16:creationId xmlns:a16="http://schemas.microsoft.com/office/drawing/2014/main" id="{C80A1DC1-35A2-4965-A938-3ED772252F02}"/>
                </a:ext>
              </a:extLst>
            </p:cNvPr>
            <p:cNvSpPr txBox="1"/>
            <p:nvPr/>
          </p:nvSpPr>
          <p:spPr>
            <a:xfrm>
              <a:off x="4154780" y="679314"/>
              <a:ext cx="271044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Subgroup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T1-2,N+, HPV+</a:t>
              </a:r>
            </a:p>
          </p:txBody>
        </p:sp>
        <p:sp>
          <p:nvSpPr>
            <p:cNvPr id="9" name="Textfeld 8">
              <a:extLst>
                <a:ext uri="{FF2B5EF4-FFF2-40B4-BE49-F238E27FC236}">
                  <a16:creationId xmlns:a16="http://schemas.microsoft.com/office/drawing/2014/main" id="{1FDEF0E1-23D1-4AF6-8EE4-F071A13673FB}"/>
                </a:ext>
              </a:extLst>
            </p:cNvPr>
            <p:cNvSpPr txBox="1"/>
            <p:nvPr/>
          </p:nvSpPr>
          <p:spPr>
            <a:xfrm>
              <a:off x="618304" y="3572056"/>
              <a:ext cx="349574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Smokers in 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Subgroup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T1-2, N+, HPV+</a:t>
              </a:r>
            </a:p>
            <a:p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EEE6109B-2B20-4D10-BEBE-A4CBC3D9E909}"/>
                </a:ext>
              </a:extLst>
            </p:cNvPr>
            <p:cNvSpPr txBox="1"/>
            <p:nvPr/>
          </p:nvSpPr>
          <p:spPr>
            <a:xfrm>
              <a:off x="119450" y="3565078"/>
              <a:ext cx="489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graphicFrame>
          <p:nvGraphicFramePr>
            <p:cNvPr id="11" name="Objekt 10">
              <a:extLst>
                <a:ext uri="{FF2B5EF4-FFF2-40B4-BE49-F238E27FC236}">
                  <a16:creationId xmlns:a16="http://schemas.microsoft.com/office/drawing/2014/main" id="{90CFD883-B04B-484A-A627-13C911B9DF0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13186127"/>
                </p:ext>
              </p:extLst>
            </p:nvPr>
          </p:nvGraphicFramePr>
          <p:xfrm>
            <a:off x="-75497" y="906508"/>
            <a:ext cx="3668744" cy="255599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8" name="Prism 9" r:id="rId3" imgW="3841928" imgH="2675945" progId="Prism9.Document">
                    <p:embed/>
                  </p:oleObj>
                </mc:Choice>
                <mc:Fallback>
                  <p:oleObj name="Prism 9" r:id="rId3" imgW="3841928" imgH="2675945" progId="Prism9.Document">
                    <p:embed/>
                    <p:pic>
                      <p:nvPicPr>
                        <p:cNvPr id="6" name="Objekt 5">
                          <a:extLst>
                            <a:ext uri="{FF2B5EF4-FFF2-40B4-BE49-F238E27FC236}">
                              <a16:creationId xmlns:a16="http://schemas.microsoft.com/office/drawing/2014/main" id="{93381CCB-BCE7-457A-9B53-54D25D52B7F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-75497" y="906508"/>
                          <a:ext cx="3668744" cy="255599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2" name="Objekt 11">
              <a:extLst>
                <a:ext uri="{FF2B5EF4-FFF2-40B4-BE49-F238E27FC236}">
                  <a16:creationId xmlns:a16="http://schemas.microsoft.com/office/drawing/2014/main" id="{0F1E0DB5-5C9D-4EE8-AF23-F0464FE8941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778196835"/>
                </p:ext>
              </p:extLst>
            </p:nvPr>
          </p:nvGraphicFramePr>
          <p:xfrm>
            <a:off x="3306823" y="900682"/>
            <a:ext cx="3668744" cy="255599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9" name="Prism 9" r:id="rId5" imgW="3841928" imgH="2675945" progId="Prism9.Document">
                    <p:embed/>
                  </p:oleObj>
                </mc:Choice>
                <mc:Fallback>
                  <p:oleObj name="Prism 9" r:id="rId5" imgW="3841928" imgH="2675945" progId="Prism9.Document">
                    <p:embed/>
                    <p:pic>
                      <p:nvPicPr>
                        <p:cNvPr id="8" name="Objekt 7">
                          <a:extLst>
                            <a:ext uri="{FF2B5EF4-FFF2-40B4-BE49-F238E27FC236}">
                              <a16:creationId xmlns:a16="http://schemas.microsoft.com/office/drawing/2014/main" id="{F203B09B-9729-4338-B85B-D1CF1DC7E72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306823" y="900682"/>
                          <a:ext cx="3668744" cy="255599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3" name="Objekt 12">
              <a:extLst>
                <a:ext uri="{FF2B5EF4-FFF2-40B4-BE49-F238E27FC236}">
                  <a16:creationId xmlns:a16="http://schemas.microsoft.com/office/drawing/2014/main" id="{BF010946-B73F-4BF6-BCC1-B8B4D7E937E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49692716"/>
                </p:ext>
              </p:extLst>
            </p:nvPr>
          </p:nvGraphicFramePr>
          <p:xfrm>
            <a:off x="-86716" y="3758653"/>
            <a:ext cx="3679930" cy="256378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0" name="Prism 9" r:id="rId7" imgW="3841928" imgH="2675945" progId="Prism9.Document">
                    <p:embed/>
                  </p:oleObj>
                </mc:Choice>
                <mc:Fallback>
                  <p:oleObj name="Prism 9" r:id="rId7" imgW="3841928" imgH="2675945" progId="Prism9.Document">
                    <p:embed/>
                    <p:pic>
                      <p:nvPicPr>
                        <p:cNvPr id="3" name="Objekt 2">
                          <a:extLst>
                            <a:ext uri="{FF2B5EF4-FFF2-40B4-BE49-F238E27FC236}">
                              <a16:creationId xmlns:a16="http://schemas.microsoft.com/office/drawing/2014/main" id="{2917DE9F-CD9C-4A7B-9600-7F806321E18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-86716" y="3758653"/>
                          <a:ext cx="3679930" cy="256378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4" name="Textfeld 13">
            <a:extLst>
              <a:ext uri="{FF2B5EF4-FFF2-40B4-BE49-F238E27FC236}">
                <a16:creationId xmlns:a16="http://schemas.microsoft.com/office/drawing/2014/main" id="{5859231B-6D7C-4ACD-91ED-FAEAC731465A}"/>
              </a:ext>
            </a:extLst>
          </p:cNvPr>
          <p:cNvSpPr txBox="1"/>
          <p:nvPr/>
        </p:nvSpPr>
        <p:spPr>
          <a:xfrm>
            <a:off x="450892" y="8379113"/>
            <a:ext cx="5858933" cy="6074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ts val="1000"/>
              </a:lnSpc>
              <a:spcBef>
                <a:spcPts val="1200"/>
              </a:spcBef>
            </a:pPr>
            <a:r>
              <a:rPr lang="en-US" sz="1000" b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dditional f</a:t>
            </a:r>
            <a:r>
              <a:rPr lang="en-US" sz="10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gure </a:t>
            </a:r>
            <a:r>
              <a:rPr lang="en-US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: Gender-specific overall survival of Human papillomavirus-positive patients: 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ender-specific overall survival </a:t>
            </a:r>
            <a:r>
              <a:rPr lang="en-US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Human papillomavirus-positive (HPV+) patients (defined as </a:t>
            </a:r>
            <a:r>
              <a:rPr lang="en-US" sz="100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16+/HPV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+; n = 403); </a:t>
            </a:r>
            <a:r>
              <a:rPr lang="en-US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subgroup T1-2, N+, HPV+ (n = 203); </a:t>
            </a:r>
            <a:r>
              <a:rPr lang="en-US" sz="10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subgroup T1-2, N+, HPV+, nicotine+ (n = 72)</a:t>
            </a:r>
            <a:endParaRPr lang="de-DE" sz="10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11903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8</Words>
  <Application>Microsoft Office PowerPoint</Application>
  <PresentationFormat>Breitbild</PresentationFormat>
  <Paragraphs>7</Paragraphs>
  <Slides>1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</vt:lpstr>
      <vt:lpstr>Prism 9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harlotte Klasen</dc:creator>
  <cp:lastModifiedBy>Charlotte Klasen</cp:lastModifiedBy>
  <cp:revision>5</cp:revision>
  <dcterms:created xsi:type="dcterms:W3CDTF">2023-09-30T17:06:14Z</dcterms:created>
  <dcterms:modified xsi:type="dcterms:W3CDTF">2023-10-03T18:00:29Z</dcterms:modified>
</cp:coreProperties>
</file>